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2CD7DF-5D48-4F6A-ADEF-32011E59DBD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DF01E8-5519-40BB-B4A8-DC03D28BF22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67C477-969D-416D-B4E1-8F5CB1D98D0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7EE0B9-53B0-4931-A382-56373AF60C3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5A09EA-33FB-4AFC-9D67-4B78BFB802A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B67E90-5B17-47BD-B76C-84A75C1A67E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AF87B0-7A69-4975-A731-04B90BD203E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573A6F-4855-4D0C-B02B-92CB30642A7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87A267-54C6-431B-9577-6454E92AF05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C93A2D-E945-448B-A0A8-20A4DD20EC8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34B0E6-0650-42A0-A075-AF5D3FB7631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366872-30A0-4338-AA7F-F3DC3D5953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4E5A2B0-D7AD-423E-9B3F-6C02504B297E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"/>
          <p:cNvSpPr/>
          <p:nvPr/>
        </p:nvSpPr>
        <p:spPr>
          <a:xfrm>
            <a:off x="273960" y="376200"/>
            <a:ext cx="2350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ry Table S1.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Box 3"/>
          <p:cNvSpPr/>
          <p:nvPr/>
        </p:nvSpPr>
        <p:spPr>
          <a:xfrm>
            <a:off x="426960" y="4211640"/>
            <a:ext cx="5881680" cy="571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Supplementary Table S1. 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IC</a:t>
            </a:r>
            <a:r>
              <a:rPr b="0" lang="en-GB" sz="10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50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 values for cell death at the 24h time-point from at least three independent experiments in the indicated cell lines and in primary bortezomib (Btz)-resistant bone marrow multiple myeloma cells. NR, not reached.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3" name="Picture 1" descr=""/>
          <p:cNvPicPr/>
          <p:nvPr/>
        </p:nvPicPr>
        <p:blipFill>
          <a:blip r:embed="rId1"/>
          <a:stretch/>
        </p:blipFill>
        <p:spPr>
          <a:xfrm>
            <a:off x="1208160" y="1209600"/>
            <a:ext cx="4103640" cy="20098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TextBox 1"/>
          <p:cNvSpPr/>
          <p:nvPr/>
        </p:nvSpPr>
        <p:spPr>
          <a:xfrm>
            <a:off x="273960" y="376200"/>
            <a:ext cx="2350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ry Table S2.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5" name="Picture 1" descr=""/>
          <p:cNvPicPr/>
          <p:nvPr/>
        </p:nvPicPr>
        <p:blipFill>
          <a:blip r:embed="rId1"/>
          <a:stretch/>
        </p:blipFill>
        <p:spPr>
          <a:xfrm>
            <a:off x="549360" y="977760"/>
            <a:ext cx="5543640" cy="3551400"/>
          </a:xfrm>
          <a:prstGeom prst="rect">
            <a:avLst/>
          </a:prstGeom>
          <a:ln w="0">
            <a:noFill/>
          </a:ln>
        </p:spPr>
      </p:pic>
      <p:sp>
        <p:nvSpPr>
          <p:cNvPr id="46" name="TextBox 4"/>
          <p:cNvSpPr/>
          <p:nvPr/>
        </p:nvSpPr>
        <p:spPr>
          <a:xfrm>
            <a:off x="404640" y="5219640"/>
            <a:ext cx="5977080" cy="85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Supplementary Table S2. Relative levels of intracellular amino acids determined by GC-MS following VCP or proteasome inhibition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. A549 cell extracts were prepared as described in Materials and Methods after treatment for 8h with DBeQ (10</a:t>
            </a:r>
            <a:r>
              <a:rPr b="0" lang="el-GR" sz="1000" spc="-1" strike="noStrike">
                <a:solidFill>
                  <a:srgbClr val="000000"/>
                </a:solidFill>
                <a:latin typeface="Arial"/>
                <a:ea typeface="Arial"/>
              </a:rPr>
              <a:t>μ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), NMS-873 (10</a:t>
            </a:r>
            <a:r>
              <a:rPr b="0" lang="el-GR" sz="1000" spc="-1" strike="noStrike">
                <a:solidFill>
                  <a:srgbClr val="000000"/>
                </a:solidFill>
                <a:latin typeface="Arial"/>
                <a:ea typeface="Arial"/>
              </a:rPr>
              <a:t>μ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) or bortezomib (20nM). Data shown are the mean ± SEM relative to untreated (control) cells from 4 independent experiments. *p&lt;0.05; **p&lt;0.01; ***p&lt;0.001.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8-26T11:51:36Z</dcterms:created>
  <dc:creator>Auner, Holger</dc:creator>
  <dc:description/>
  <dc:language>en-US</dc:language>
  <cp:lastModifiedBy>R.Vijitha</cp:lastModifiedBy>
  <dcterms:modified xsi:type="dcterms:W3CDTF">2015-12-17T14:11:31Z</dcterms:modified>
  <cp:revision>2</cp:revision>
  <dc:subject/>
  <dc:title>PowerPoint Presentation</dc:title>
</cp:coreProperties>
</file>